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317" r:id="rId2"/>
    <p:sldId id="256" r:id="rId3"/>
    <p:sldId id="263" r:id="rId4"/>
    <p:sldId id="262" r:id="rId5"/>
    <p:sldId id="261" r:id="rId6"/>
    <p:sldId id="319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浅色样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无样式，无网格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7" d="100"/>
          <a:sy n="77" d="100"/>
        </p:scale>
        <p:origin x="64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F62250D-7FE0-46D6-96AC-D7D591994705}" type="datetimeFigureOut">
              <a:rPr lang="zh-CN" altLang="en-US" smtClean="0"/>
              <a:t>2022/7/2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7DFADA3-F200-4089-ACBC-D2A25007E7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235772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35D97B8-9BDF-4754-9C94-8F949673B6D0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169894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35D97B8-9BDF-4754-9C94-8F949673B6D0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736558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02EA657-0C8A-2EE9-9BCF-DB87863B9CD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9BB1C60D-1186-65F5-D461-3B1EA08EE0C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6909E36-5305-35E0-F9A3-46DEEEDAE2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92294-6E95-4CC5-A367-B2EA7B71FACE}" type="datetimeFigureOut">
              <a:rPr lang="zh-CN" altLang="en-US" smtClean="0"/>
              <a:t>2022/7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DAF8DDB-E34A-01AB-9BF8-662155D0E9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1D96362-5CEB-9C3F-B545-0B35B1BA93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DC70C-0F3E-42CB-940E-C9EDA6B2AF4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32620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F46022F-F580-94CA-EB89-8DB4918DF1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88C9F8E-F2B3-1BC6-43E3-9EA3C6A8B2E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A2D1858-E9F3-1C6F-9999-3C802F0D03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92294-6E95-4CC5-A367-B2EA7B71FACE}" type="datetimeFigureOut">
              <a:rPr lang="zh-CN" altLang="en-US" smtClean="0"/>
              <a:t>2022/7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E79306A-0409-CCD1-D5CB-92620AED04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B2CF7F0-FD7D-12DD-BDFA-30DC40BF28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DC70C-0F3E-42CB-940E-C9EDA6B2AF4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28743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C85D72C5-B346-B4C0-EA01-5736A857330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45AA9BA-FD48-4812-5421-0A354A8FD40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2A9CD22-0492-4AB2-AF96-88FDB94499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92294-6E95-4CC5-A367-B2EA7B71FACE}" type="datetimeFigureOut">
              <a:rPr lang="zh-CN" altLang="en-US" smtClean="0"/>
              <a:t>2022/7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A34D4F4-4F5F-982A-9E49-3DC9F08AF6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88A1558-E1B9-43C8-3300-1862D05267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DC70C-0F3E-42CB-940E-C9EDA6B2AF4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936879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D06FC76-3EBA-7C19-D639-24F6D3BEBB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7E4BE45-E56C-CE17-FF82-E543CCE148B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67220BE-0744-F778-B41E-E76207798B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92294-6E95-4CC5-A367-B2EA7B71FACE}" type="datetimeFigureOut">
              <a:rPr lang="zh-CN" altLang="en-US" smtClean="0"/>
              <a:t>2022/7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7D8D6D4-4D25-AC7D-E349-DDB20773DE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31A9C14-B72B-F7CB-779D-01B72D2433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DC70C-0F3E-42CB-940E-C9EDA6B2AF4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86347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155E03D-146D-4C09-29CC-4E19306989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C2CBC2C-A0E0-0383-821A-6E09F83E54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0C58877-BD96-A537-9494-2950CD19B4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92294-6E95-4CC5-A367-B2EA7B71FACE}" type="datetimeFigureOut">
              <a:rPr lang="zh-CN" altLang="en-US" smtClean="0"/>
              <a:t>2022/7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3F2BC85-C044-790E-64F4-5047547ABD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775C7FD-1DD3-9039-8740-387B2E0C49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DC70C-0F3E-42CB-940E-C9EDA6B2AF4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45384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FBA28F8-1162-603B-DB3C-3644B45D39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A965D68-DE7B-CB43-4DA9-EDE9307BCFA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49833FD-051F-2887-E900-3E8B0FFC42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5AB98EE-E20B-80BD-2E20-40DB2EBBB5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92294-6E95-4CC5-A367-B2EA7B71FACE}" type="datetimeFigureOut">
              <a:rPr lang="zh-CN" altLang="en-US" smtClean="0"/>
              <a:t>2022/7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BFFBD36-7A36-2B10-2D3F-6F73660FD0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EC69D5A-7798-401F-6C62-5B3F4144DF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DC70C-0F3E-42CB-940E-C9EDA6B2AF4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1313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D01BE9F-1B36-06A5-731A-AEC60F4266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A682429-77AE-E298-6E4E-48797C32B4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AEC2A73-A121-1435-BF20-9D02EFC7914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86381EE6-5918-E0C0-657F-5C312D4EB33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BF863359-0C35-F9F9-32BA-4AFF20B3EFD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E500B12E-16D6-7A3B-2BAE-CB7B238869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92294-6E95-4CC5-A367-B2EA7B71FACE}" type="datetimeFigureOut">
              <a:rPr lang="zh-CN" altLang="en-US" smtClean="0"/>
              <a:t>2022/7/2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59007B7-D733-E78F-8A83-6F35266C08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6840159D-6D77-5F5C-6512-BD108992AD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DC70C-0F3E-42CB-940E-C9EDA6B2AF4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66545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10ECC89-A342-B610-D27E-22134EDA89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F22F6F7E-6FD6-D9C8-ED61-5AE8075A25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92294-6E95-4CC5-A367-B2EA7B71FACE}" type="datetimeFigureOut">
              <a:rPr lang="zh-CN" altLang="en-US" smtClean="0"/>
              <a:t>2022/7/2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7977457-8FF3-941D-4B2B-A319F00E18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77FD8C6A-E6B5-4E02-C776-596F6AC2E6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DC70C-0F3E-42CB-940E-C9EDA6B2AF4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83186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200C5EBE-22CF-BBB6-5355-8AA32695CA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92294-6E95-4CC5-A367-B2EA7B71FACE}" type="datetimeFigureOut">
              <a:rPr lang="zh-CN" altLang="en-US" smtClean="0"/>
              <a:t>2022/7/2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50D47F66-CF64-6234-8DD2-FE90B8CC8F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7D9F3268-53EE-D68F-B626-6DB8C43609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DC70C-0F3E-42CB-940E-C9EDA6B2AF4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79325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876C3D5-FE6E-6965-BAD2-8B2A00A4C5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EABF7F7-2A14-54B6-DD95-ABC8D52BDE3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5AED412-B668-B065-738F-C4B0F1A6AFD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43512FD-0B52-B5A3-2CC5-EFE00B0816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92294-6E95-4CC5-A367-B2EA7B71FACE}" type="datetimeFigureOut">
              <a:rPr lang="zh-CN" altLang="en-US" smtClean="0"/>
              <a:t>2022/7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9D5B364-97F2-9E30-4612-6C5DC5C94B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C8FB6F5-38B6-D3D8-D755-94B98CEE30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DC70C-0F3E-42CB-940E-C9EDA6B2AF4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21997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C866423-59AE-682E-3DDC-9F22AB6B23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06EB4FD-97E1-BA85-6DE8-DA84FD522C9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86BF405-6EC3-C518-DB83-5980DCDB435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8FA83F1-385F-E904-DCCD-4241523AAA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92294-6E95-4CC5-A367-B2EA7B71FACE}" type="datetimeFigureOut">
              <a:rPr lang="zh-CN" altLang="en-US" smtClean="0"/>
              <a:t>2022/7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CCD18C7-7239-CF9B-2CFB-F6795A875A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6BEF8E0-4CDD-28F1-F769-77A3C445A0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3DC70C-0F3E-42CB-940E-C9EDA6B2AF4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59314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5217DB7B-5E22-3830-D915-8164E25960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632699A-7E24-9F12-80AF-E3504912B7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981C69F-456A-E7E5-C92E-9FA62DE7AEF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B92294-6E95-4CC5-A367-B2EA7B71FACE}" type="datetimeFigureOut">
              <a:rPr lang="zh-CN" altLang="en-US" smtClean="0"/>
              <a:t>2022/7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A8212E8-AA41-7FB9-55A1-BA817400717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367BD5D-D6B0-B14E-02B7-904ED69347E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3DC70C-0F3E-42CB-940E-C9EDA6B2AF4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579065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minlibao_bob@163.com" TargetMode="Externa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ncbi.nlm.nih.gov/assembly/GCF_000317415.1" TargetMode="Externa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9A50BDD3-E75E-244B-3F06-162D5F9440F1}"/>
              </a:ext>
            </a:extLst>
          </p:cNvPr>
          <p:cNvSpPr txBox="1"/>
          <p:nvPr/>
        </p:nvSpPr>
        <p:spPr>
          <a:xfrm>
            <a:off x="689295" y="1113374"/>
            <a:ext cx="10813410" cy="301774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zh-CN" sz="2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Dodder-transmitted mobile systemic signals activate salt-stress response Characterized by a transcriptome change in </a:t>
            </a:r>
            <a:r>
              <a:rPr lang="en-US" altLang="zh-CN" sz="2400" b="1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itrus sinensis</a:t>
            </a:r>
            <a:endParaRPr lang="zh-CN" altLang="zh-CN" sz="24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ctr">
              <a:lnSpc>
                <a:spcPct val="15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huo Duan</a:t>
            </a:r>
            <a:r>
              <a:rPr lang="en-US" altLang="zh-CN" sz="1200" kern="100" baseline="300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altLang="zh-CN" sz="1200" kern="0" baseline="30000" dirty="0">
                <a:solidFill>
                  <a:srgbClr val="0E101A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†*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Zhou Xu</a:t>
            </a:r>
            <a:r>
              <a:rPr lang="en-US" altLang="zh-CN" sz="1200" kern="100" baseline="300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altLang="zh-CN" sz="1200" kern="0" baseline="30000" dirty="0">
                <a:solidFill>
                  <a:srgbClr val="0E101A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†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Xin-Yu Li</a:t>
            </a:r>
            <a:r>
              <a:rPr lang="en-US" altLang="zh-CN" sz="1200" kern="100" baseline="300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Ping Liao</a:t>
            </a:r>
            <a:r>
              <a:rPr lang="en-US" altLang="zh-CN" sz="1200" kern="100" baseline="300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2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Hongkun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Qin</a:t>
            </a:r>
            <a:r>
              <a:rPr lang="en-US" altLang="zh-CN" sz="1200" kern="100" baseline="300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2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Yaping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Mao</a:t>
            </a:r>
            <a:r>
              <a:rPr lang="en-US" altLang="zh-CN" sz="1200" kern="100" baseline="300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Wen-Shan Dai</a:t>
            </a:r>
            <a:r>
              <a:rPr lang="en-US" altLang="zh-CN" sz="1200" kern="100" baseline="300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Hai-</a:t>
            </a:r>
            <a:r>
              <a:rPr lang="en-US" altLang="zh-CN" sz="12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Jie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Ma</a:t>
            </a:r>
            <a:r>
              <a:rPr lang="en-US" altLang="zh-CN" sz="1200" kern="100" baseline="300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Min-Li Bao</a:t>
            </a:r>
            <a:r>
              <a:rPr lang="en-US" altLang="zh-CN" sz="1200" kern="100" baseline="300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altLang="zh-CN" sz="1200" kern="0" baseline="30000" dirty="0">
                <a:solidFill>
                  <a:srgbClr val="0E101A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*</a:t>
            </a:r>
            <a:endParaRPr lang="zh-CN" alt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altLang="zh-CN" sz="1200" kern="100" baseline="300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hina-USA Citrus Huanglongbing Joint Laboratory, National Navel Orange Engineering Research Center, Gannan Normal University, Ganzhou, Jiangxi 341000, China</a:t>
            </a:r>
            <a:endParaRPr lang="zh-CN" alt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l">
              <a:lnSpc>
                <a:spcPct val="150000"/>
              </a:lnSpc>
            </a:pPr>
            <a:r>
              <a:rPr lang="en-US" altLang="zh-CN" sz="1200" kern="100" baseline="300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ollege of Bioscience and Biotechnology, Yangzhou University, Yangzhou, Jiangsu, 225009, China.</a:t>
            </a:r>
            <a:endParaRPr lang="zh-CN" alt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*Corresponding author: Minli Bao, Email: </a:t>
            </a:r>
            <a:r>
              <a:rPr lang="en-US" altLang="zh-CN" sz="1200" u="sng" kern="100" dirty="0">
                <a:solidFill>
                  <a:srgbClr val="0563C1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hlinkClick r:id="rId2"/>
              </a:rPr>
              <a:t>minlibao_bob@163.com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;</a:t>
            </a:r>
            <a:endParaRPr lang="zh-CN" alt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CN" sz="1200" kern="0" baseline="30000" dirty="0">
                <a:solidFill>
                  <a:srgbClr val="0E101A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† </a:t>
            </a:r>
            <a:r>
              <a:rPr lang="en-US" altLang="zh-CN" sz="1200" kern="0" dirty="0">
                <a:solidFill>
                  <a:srgbClr val="0E101A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se authors contributed equally to this work</a:t>
            </a:r>
            <a:endParaRPr lang="zh-CN" alt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B4B158CA-BD0A-5B32-9431-C024A8AD1535}"/>
              </a:ext>
            </a:extLst>
          </p:cNvPr>
          <p:cNvSpPr txBox="1"/>
          <p:nvPr/>
        </p:nvSpPr>
        <p:spPr>
          <a:xfrm>
            <a:off x="813730" y="5512639"/>
            <a:ext cx="2511200" cy="4639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Table 1-4</a:t>
            </a:r>
            <a:endParaRPr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26367197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表格 10">
            <a:extLst>
              <a:ext uri="{FF2B5EF4-FFF2-40B4-BE49-F238E27FC236}">
                <a16:creationId xmlns:a16="http://schemas.microsoft.com/office/drawing/2014/main" id="{B462FD69-3C29-C8AA-39B7-106D0AE5D91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24063534"/>
              </p:ext>
            </p:extLst>
          </p:nvPr>
        </p:nvGraphicFramePr>
        <p:xfrm>
          <a:off x="1148306" y="899064"/>
          <a:ext cx="9610162" cy="5386405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703842">
                  <a:extLst>
                    <a:ext uri="{9D8B030D-6E8A-4147-A177-3AD203B41FA5}">
                      <a16:colId xmlns:a16="http://schemas.microsoft.com/office/drawing/2014/main" val="1520438866"/>
                    </a:ext>
                  </a:extLst>
                </a:gridCol>
                <a:gridCol w="1317720">
                  <a:extLst>
                    <a:ext uri="{9D8B030D-6E8A-4147-A177-3AD203B41FA5}">
                      <a16:colId xmlns:a16="http://schemas.microsoft.com/office/drawing/2014/main" val="1970249078"/>
                    </a:ext>
                  </a:extLst>
                </a:gridCol>
                <a:gridCol w="1317720">
                  <a:extLst>
                    <a:ext uri="{9D8B030D-6E8A-4147-A177-3AD203B41FA5}">
                      <a16:colId xmlns:a16="http://schemas.microsoft.com/office/drawing/2014/main" val="4195186464"/>
                    </a:ext>
                  </a:extLst>
                </a:gridCol>
                <a:gridCol w="1317720">
                  <a:extLst>
                    <a:ext uri="{9D8B030D-6E8A-4147-A177-3AD203B41FA5}">
                      <a16:colId xmlns:a16="http://schemas.microsoft.com/office/drawing/2014/main" val="495309909"/>
                    </a:ext>
                  </a:extLst>
                </a:gridCol>
                <a:gridCol w="1317720">
                  <a:extLst>
                    <a:ext uri="{9D8B030D-6E8A-4147-A177-3AD203B41FA5}">
                      <a16:colId xmlns:a16="http://schemas.microsoft.com/office/drawing/2014/main" val="2351505060"/>
                    </a:ext>
                  </a:extLst>
                </a:gridCol>
                <a:gridCol w="1317720">
                  <a:extLst>
                    <a:ext uri="{9D8B030D-6E8A-4147-A177-3AD203B41FA5}">
                      <a16:colId xmlns:a16="http://schemas.microsoft.com/office/drawing/2014/main" val="1675892115"/>
                    </a:ext>
                  </a:extLst>
                </a:gridCol>
                <a:gridCol w="1317720">
                  <a:extLst>
                    <a:ext uri="{9D8B030D-6E8A-4147-A177-3AD203B41FA5}">
                      <a16:colId xmlns:a16="http://schemas.microsoft.com/office/drawing/2014/main" val="1506645459"/>
                    </a:ext>
                  </a:extLst>
                </a:gridCol>
              </a:tblGrid>
              <a:tr h="28650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mple Name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Raw Reads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Clean Reads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Clean Bases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ean Reads Q20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ean Reads Q30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ean Reads Ratio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35327438"/>
                  </a:ext>
                </a:extLst>
              </a:tr>
              <a:tr h="28650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odder0hpi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.33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29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79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75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7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49540384"/>
                  </a:ext>
                </a:extLst>
              </a:tr>
              <a:tr h="28650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odder12hpi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.33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34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8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73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.94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81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extLst>
                  <a:ext uri="{0D108BD9-81ED-4DB2-BD59-A6C34878D82A}">
                    <a16:rowId xmlns:a16="http://schemas.microsoft.com/office/drawing/2014/main" val="230245350"/>
                  </a:ext>
                </a:extLst>
              </a:tr>
              <a:tr h="28650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odder24hpi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.33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36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8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74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.98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84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extLst>
                  <a:ext uri="{0D108BD9-81ED-4DB2-BD59-A6C34878D82A}">
                    <a16:rowId xmlns:a16="http://schemas.microsoft.com/office/drawing/2014/main" val="1273618115"/>
                  </a:ext>
                </a:extLst>
              </a:tr>
              <a:tr h="1464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alt0hpi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.33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45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82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.03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4.44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04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extLst>
                  <a:ext uri="{0D108BD9-81ED-4DB2-BD59-A6C34878D82A}">
                    <a16:rowId xmlns:a16="http://schemas.microsoft.com/office/drawing/2014/main" val="1807500815"/>
                  </a:ext>
                </a:extLst>
              </a:tr>
              <a:tr h="28650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alt12hpi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.33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43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81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62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.67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99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extLst>
                  <a:ext uri="{0D108BD9-81ED-4DB2-BD59-A6C34878D82A}">
                    <a16:rowId xmlns:a16="http://schemas.microsoft.com/office/drawing/2014/main" val="1560767851"/>
                  </a:ext>
                </a:extLst>
              </a:tr>
              <a:tr h="28650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alt24hpi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.33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13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77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87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.27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36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extLst>
                  <a:ext uri="{0D108BD9-81ED-4DB2-BD59-A6C34878D82A}">
                    <a16:rowId xmlns:a16="http://schemas.microsoft.com/office/drawing/2014/main" val="2694798781"/>
                  </a:ext>
                </a:extLst>
              </a:tr>
              <a:tr h="28650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odder0hpi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57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.09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61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7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.86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74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extLst>
                  <a:ext uri="{0D108BD9-81ED-4DB2-BD59-A6C34878D82A}">
                    <a16:rowId xmlns:a16="http://schemas.microsoft.com/office/drawing/2014/main" val="1004421544"/>
                  </a:ext>
                </a:extLst>
              </a:tr>
              <a:tr h="28650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odder12hpi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.33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23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78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84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.22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57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extLst>
                  <a:ext uri="{0D108BD9-81ED-4DB2-BD59-A6C34878D82A}">
                    <a16:rowId xmlns:a16="http://schemas.microsoft.com/office/drawing/2014/main" val="799726088"/>
                  </a:ext>
                </a:extLst>
              </a:tr>
              <a:tr h="28650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odder24hpi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.33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08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76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88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.31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24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extLst>
                  <a:ext uri="{0D108BD9-81ED-4DB2-BD59-A6C34878D82A}">
                    <a16:rowId xmlns:a16="http://schemas.microsoft.com/office/drawing/2014/main" val="1384762243"/>
                  </a:ext>
                </a:extLst>
              </a:tr>
              <a:tr h="1464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Salt0hpi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.33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26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79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71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.91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64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extLst>
                  <a:ext uri="{0D108BD9-81ED-4DB2-BD59-A6C34878D82A}">
                    <a16:rowId xmlns:a16="http://schemas.microsoft.com/office/drawing/2014/main" val="2046635380"/>
                  </a:ext>
                </a:extLst>
              </a:tr>
              <a:tr h="28650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Salt12hpi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.08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.31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65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98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.57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.27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extLst>
                  <a:ext uri="{0D108BD9-81ED-4DB2-BD59-A6C34878D82A}">
                    <a16:rowId xmlns:a16="http://schemas.microsoft.com/office/drawing/2014/main" val="1661404504"/>
                  </a:ext>
                </a:extLst>
              </a:tr>
              <a:tr h="28650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Salt24hpi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.33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.95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74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81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.16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4.98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extLst>
                  <a:ext uri="{0D108BD9-81ED-4DB2-BD59-A6C34878D82A}">
                    <a16:rowId xmlns:a16="http://schemas.microsoft.com/office/drawing/2014/main" val="2933089428"/>
                  </a:ext>
                </a:extLst>
              </a:tr>
              <a:tr h="28650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odder0hpi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.33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.02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6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48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3.44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3.02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extLst>
                  <a:ext uri="{0D108BD9-81ED-4DB2-BD59-A6C34878D82A}">
                    <a16:rowId xmlns:a16="http://schemas.microsoft.com/office/drawing/2014/main" val="2190375731"/>
                  </a:ext>
                </a:extLst>
              </a:tr>
              <a:tr h="28650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odder12hpi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.33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46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82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5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3.48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06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extLst>
                  <a:ext uri="{0D108BD9-81ED-4DB2-BD59-A6C34878D82A}">
                    <a16:rowId xmlns:a16="http://schemas.microsoft.com/office/drawing/2014/main" val="3183538626"/>
                  </a:ext>
                </a:extLst>
              </a:tr>
              <a:tr h="28650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odder24hpi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57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.01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6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38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3.16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58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extLst>
                  <a:ext uri="{0D108BD9-81ED-4DB2-BD59-A6C34878D82A}">
                    <a16:rowId xmlns:a16="http://schemas.microsoft.com/office/drawing/2014/main" val="2992663637"/>
                  </a:ext>
                </a:extLst>
              </a:tr>
              <a:tr h="1464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Salt0hpi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.33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03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75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91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.39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14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extLst>
                  <a:ext uri="{0D108BD9-81ED-4DB2-BD59-A6C34878D82A}">
                    <a16:rowId xmlns:a16="http://schemas.microsoft.com/office/drawing/2014/main" val="2171574831"/>
                  </a:ext>
                </a:extLst>
              </a:tr>
              <a:tr h="28650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Salt12hpi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.33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04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76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9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.33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16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extLst>
                  <a:ext uri="{0D108BD9-81ED-4DB2-BD59-A6C34878D82A}">
                    <a16:rowId xmlns:a16="http://schemas.microsoft.com/office/drawing/2014/main" val="785992277"/>
                  </a:ext>
                </a:extLst>
              </a:tr>
              <a:tr h="28650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Salt24hpi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.33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75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83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.2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08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515" marR="5515" marT="5515" marB="0" anchor="ctr"/>
                </a:tc>
                <a:extLst>
                  <a:ext uri="{0D108BD9-81ED-4DB2-BD59-A6C34878D82A}">
                    <a16:rowId xmlns:a16="http://schemas.microsoft.com/office/drawing/2014/main" val="3503494866"/>
                  </a:ext>
                </a:extLst>
              </a:tr>
            </a:tbl>
          </a:graphicData>
        </a:graphic>
      </p:graphicFrame>
      <p:sp>
        <p:nvSpPr>
          <p:cNvPr id="4" name="文本框 21">
            <a:extLst>
              <a:ext uri="{FF2B5EF4-FFF2-40B4-BE49-F238E27FC236}">
                <a16:creationId xmlns:a16="http://schemas.microsoft.com/office/drawing/2014/main" id="{D048F6E9-BE82-B88B-19EF-637DE39396B0}"/>
              </a:ext>
            </a:extLst>
          </p:cNvPr>
          <p:cNvSpPr txBox="1"/>
          <p:nvPr/>
        </p:nvSpPr>
        <p:spPr>
          <a:xfrm>
            <a:off x="82293" y="83456"/>
            <a:ext cx="46189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Table 1</a:t>
            </a: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3116F921-4DE5-65AC-924F-DC2290CE9029}"/>
              </a:ext>
            </a:extLst>
          </p:cNvPr>
          <p:cNvSpPr txBox="1"/>
          <p:nvPr/>
        </p:nvSpPr>
        <p:spPr>
          <a:xfrm>
            <a:off x="1148306" y="560510"/>
            <a:ext cx="867156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Summary of Reads filtering in this study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102198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>
            <a:extLst>
              <a:ext uri="{FF2B5EF4-FFF2-40B4-BE49-F238E27FC236}">
                <a16:creationId xmlns:a16="http://schemas.microsoft.com/office/drawing/2014/main" id="{F737885A-38DF-5398-B3E1-A8790B84E87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23742762"/>
              </p:ext>
            </p:extLst>
          </p:nvPr>
        </p:nvGraphicFramePr>
        <p:xfrm>
          <a:off x="1880571" y="1105257"/>
          <a:ext cx="8918538" cy="5324594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503792">
                  <a:extLst>
                    <a:ext uri="{9D8B030D-6E8A-4147-A177-3AD203B41FA5}">
                      <a16:colId xmlns:a16="http://schemas.microsoft.com/office/drawing/2014/main" val="1018527605"/>
                    </a:ext>
                  </a:extLst>
                </a:gridCol>
                <a:gridCol w="2267623">
                  <a:extLst>
                    <a:ext uri="{9D8B030D-6E8A-4147-A177-3AD203B41FA5}">
                      <a16:colId xmlns:a16="http://schemas.microsoft.com/office/drawing/2014/main" val="3518461488"/>
                    </a:ext>
                  </a:extLst>
                </a:gridCol>
                <a:gridCol w="1933447">
                  <a:extLst>
                    <a:ext uri="{9D8B030D-6E8A-4147-A177-3AD203B41FA5}">
                      <a16:colId xmlns:a16="http://schemas.microsoft.com/office/drawing/2014/main" val="2877365929"/>
                    </a:ext>
                  </a:extLst>
                </a:gridCol>
                <a:gridCol w="3213676">
                  <a:extLst>
                    <a:ext uri="{9D8B030D-6E8A-4147-A177-3AD203B41FA5}">
                      <a16:colId xmlns:a16="http://schemas.microsoft.com/office/drawing/2014/main" val="1814174544"/>
                    </a:ext>
                  </a:extLst>
                </a:gridCol>
              </a:tblGrid>
              <a:tr h="31915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mple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Clean Reads (M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Mapping(%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iquely Mapping(%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4831515"/>
                  </a:ext>
                </a:extLst>
              </a:tr>
              <a:tr h="2780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odder0hpi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29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.46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.71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429048438"/>
                  </a:ext>
                </a:extLst>
              </a:tr>
              <a:tr h="2780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odder12hpi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34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.81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.35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072770837"/>
                  </a:ext>
                </a:extLst>
              </a:tr>
              <a:tr h="2780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odder24hpi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36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.94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.18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87343910"/>
                  </a:ext>
                </a:extLst>
              </a:tr>
              <a:tr h="2780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alt0hpi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45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.66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.53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781354123"/>
                  </a:ext>
                </a:extLst>
              </a:tr>
              <a:tr h="2780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alt12hpi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43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.69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.57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45532281"/>
                  </a:ext>
                </a:extLst>
              </a:tr>
              <a:tr h="2780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alt24hpi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13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.65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.66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788018372"/>
                  </a:ext>
                </a:extLst>
              </a:tr>
              <a:tr h="2780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odder0hpi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.09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8.47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.09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63441336"/>
                  </a:ext>
                </a:extLst>
              </a:tr>
              <a:tr h="2780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odder12hpi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23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.22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.04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579299315"/>
                  </a:ext>
                </a:extLst>
              </a:tr>
              <a:tr h="2780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odder24hpi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08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8.56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.66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773171356"/>
                  </a:ext>
                </a:extLst>
              </a:tr>
              <a:tr h="2780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Salt0hpi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26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8.49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148313257"/>
                  </a:ext>
                </a:extLst>
              </a:tr>
              <a:tr h="2780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Salt12hpi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.31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.34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.12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45532194"/>
                  </a:ext>
                </a:extLst>
              </a:tr>
              <a:tr h="2780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Salt24hpi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.95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8.2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.91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958810694"/>
                  </a:ext>
                </a:extLst>
              </a:tr>
              <a:tr h="2780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odder0hpi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.02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.78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.33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46964927"/>
                  </a:ext>
                </a:extLst>
              </a:tr>
              <a:tr h="2780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odder12hpi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46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.59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.24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936860276"/>
                  </a:ext>
                </a:extLst>
              </a:tr>
              <a:tr h="2780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odder24hpi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.01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.71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.89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423507278"/>
                  </a:ext>
                </a:extLst>
              </a:tr>
              <a:tr h="2780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Salt0hpi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03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.78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.22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755054914"/>
                  </a:ext>
                </a:extLst>
              </a:tr>
              <a:tr h="2780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Salt12hpi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04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.18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.85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588427733"/>
                  </a:ext>
                </a:extLst>
              </a:tr>
              <a:tr h="2780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Salt24hpi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.99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.13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644134096"/>
                  </a:ext>
                </a:extLst>
              </a:tr>
            </a:tbl>
          </a:graphicData>
        </a:graphic>
      </p:graphicFrame>
      <p:sp>
        <p:nvSpPr>
          <p:cNvPr id="5" name="文本框 4">
            <a:extLst>
              <a:ext uri="{FF2B5EF4-FFF2-40B4-BE49-F238E27FC236}">
                <a16:creationId xmlns:a16="http://schemas.microsoft.com/office/drawing/2014/main" id="{A4627010-BE13-02A1-D486-D4F00E1A3E42}"/>
              </a:ext>
            </a:extLst>
          </p:cNvPr>
          <p:cNvSpPr txBox="1">
            <a:spLocks/>
          </p:cNvSpPr>
          <p:nvPr/>
        </p:nvSpPr>
        <p:spPr>
          <a:xfrm>
            <a:off x="1880571" y="685125"/>
            <a:ext cx="867156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Summary of clean reads mapping in this study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EB1BB309-616B-93C7-D85C-035D58D7E32D}"/>
              </a:ext>
            </a:extLst>
          </p:cNvPr>
          <p:cNvCxnSpPr>
            <a:cxnSpLocks noGrp="1" noRot="1" noMove="1" noResize="1" noEditPoints="1" noAdjustHandles="1" noChangeArrowheads="1" noChangeShapeType="1"/>
          </p:cNvCxnSpPr>
          <p:nvPr/>
        </p:nvCxnSpPr>
        <p:spPr>
          <a:xfrm>
            <a:off x="1892603" y="1383634"/>
            <a:ext cx="891853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文本框 6">
            <a:extLst>
              <a:ext uri="{FF2B5EF4-FFF2-40B4-BE49-F238E27FC236}">
                <a16:creationId xmlns:a16="http://schemas.microsoft.com/office/drawing/2014/main" id="{5EFACAA9-EC6D-E137-3E08-2357A0DE89C7}"/>
              </a:ext>
            </a:extLst>
          </p:cNvPr>
          <p:cNvSpPr txBox="1"/>
          <p:nvPr/>
        </p:nvSpPr>
        <p:spPr>
          <a:xfrm>
            <a:off x="1794293" y="6477395"/>
            <a:ext cx="11956212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Bowtie2 to align the clean reads to the reference genes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1200" b="0" i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Citrus_sinensis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zh-CN" altLang="en-US" sz="12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zh-CN" sz="1200" b="0" i="0" strike="noStrike" dirty="0">
                <a:effectLst/>
                <a:latin typeface="Arial" panose="020B0604020202020204" pitchFamily="34" charset="0"/>
                <a:cs typeface="Arial" panose="020B0604020202020204" pitchFamily="34" charset="0"/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GC</a:t>
            </a:r>
            <a:r>
              <a:rPr lang="en-US" altLang="zh-CN" sz="1200" b="0" i="0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F_000317415.1_Csi_valencia_1.0)</a:t>
            </a:r>
            <a:endParaRPr lang="en-US" altLang="zh-CN" sz="1200" b="0" i="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21">
            <a:extLst>
              <a:ext uri="{FF2B5EF4-FFF2-40B4-BE49-F238E27FC236}">
                <a16:creationId xmlns:a16="http://schemas.microsoft.com/office/drawing/2014/main" id="{D41D2ADF-BC29-5F74-3564-DEA42E7F3282}"/>
              </a:ext>
            </a:extLst>
          </p:cNvPr>
          <p:cNvSpPr txBox="1"/>
          <p:nvPr/>
        </p:nvSpPr>
        <p:spPr>
          <a:xfrm>
            <a:off x="165471" y="173150"/>
            <a:ext cx="46189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Table 2</a:t>
            </a:r>
          </a:p>
        </p:txBody>
      </p:sp>
    </p:spTree>
    <p:extLst>
      <p:ext uri="{BB962C8B-B14F-4D97-AF65-F5344CB8AC3E}">
        <p14:creationId xmlns:p14="http://schemas.microsoft.com/office/powerpoint/2010/main" val="37162030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727F0BB1-1C30-F9E9-C269-37924551117F}"/>
              </a:ext>
            </a:extLst>
          </p:cNvPr>
          <p:cNvGrpSpPr/>
          <p:nvPr/>
        </p:nvGrpSpPr>
        <p:grpSpPr>
          <a:xfrm>
            <a:off x="1907699" y="702823"/>
            <a:ext cx="8814260" cy="5656872"/>
            <a:chOff x="1752058" y="521004"/>
            <a:chExt cx="8814260" cy="5656872"/>
          </a:xfrm>
        </p:grpSpPr>
        <p:graphicFrame>
          <p:nvGraphicFramePr>
            <p:cNvPr id="5" name="表格 4">
              <a:extLst>
                <a:ext uri="{FF2B5EF4-FFF2-40B4-BE49-F238E27FC236}">
                  <a16:creationId xmlns:a16="http://schemas.microsoft.com/office/drawing/2014/main" id="{2AE65387-D6D4-847E-8F51-AE7B5115444A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70529018"/>
                </p:ext>
              </p:extLst>
            </p:nvPr>
          </p:nvGraphicFramePr>
          <p:xfrm>
            <a:off x="1752058" y="521004"/>
            <a:ext cx="8814260" cy="5656872"/>
          </p:xfrm>
          <a:graphic>
            <a:graphicData uri="http://schemas.openxmlformats.org/drawingml/2006/table">
              <a:tbl>
                <a:tblPr>
                  <a:tableStyleId>{9D7B26C5-4107-4FEC-AEDC-1716B250A1EF}</a:tableStyleId>
                </a:tblPr>
                <a:tblGrid>
                  <a:gridCol w="952653">
                    <a:extLst>
                      <a:ext uri="{9D8B030D-6E8A-4147-A177-3AD203B41FA5}">
                        <a16:colId xmlns:a16="http://schemas.microsoft.com/office/drawing/2014/main" val="1379059727"/>
                      </a:ext>
                    </a:extLst>
                  </a:gridCol>
                  <a:gridCol w="1530503">
                    <a:extLst>
                      <a:ext uri="{9D8B030D-6E8A-4147-A177-3AD203B41FA5}">
                        <a16:colId xmlns:a16="http://schemas.microsoft.com/office/drawing/2014/main" val="1702008205"/>
                      </a:ext>
                    </a:extLst>
                  </a:gridCol>
                  <a:gridCol w="776441">
                    <a:extLst>
                      <a:ext uri="{9D8B030D-6E8A-4147-A177-3AD203B41FA5}">
                        <a16:colId xmlns:a16="http://schemas.microsoft.com/office/drawing/2014/main" val="3293458566"/>
                      </a:ext>
                    </a:extLst>
                  </a:gridCol>
                  <a:gridCol w="5554663">
                    <a:extLst>
                      <a:ext uri="{9D8B030D-6E8A-4147-A177-3AD203B41FA5}">
                        <a16:colId xmlns:a16="http://schemas.microsoft.com/office/drawing/2014/main" val="1822961654"/>
                      </a:ext>
                    </a:extLst>
                  </a:gridCol>
                </a:tblGrid>
                <a:tr h="215538">
                  <a:tc>
                    <a:txBody>
                      <a:bodyPr/>
                      <a:lstStyle/>
                      <a:p>
                        <a:pPr algn="ctr" fontAlgn="ctr"/>
                        <a:r>
                          <a:rPr lang="en-US" sz="1400" b="1" u="none" strike="noStrike" dirty="0">
                            <a:effectLst/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Gene ID</a:t>
                        </a:r>
                        <a:endPara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endParaRPr>
                      </a:p>
                    </a:txBody>
                    <a:tcPr marL="8808" marR="8808" marT="8808" marB="0" anchor="ctr"/>
                  </a:tc>
                  <a:tc>
                    <a:txBody>
                      <a:bodyPr/>
                      <a:lstStyle/>
                      <a:p>
                        <a:pPr algn="ctr" fontAlgn="ctr"/>
                        <a:r>
                          <a:rPr lang="en-US" sz="1400" b="1" i="0" u="none" strike="noStrike" dirty="0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Group D</a:t>
                        </a:r>
                      </a:p>
                    </a:txBody>
                    <a:tcPr marL="8808" marR="8808" marT="8808" marB="0" anchor="ctr"/>
                  </a:tc>
                  <a:tc>
                    <a:txBody>
                      <a:bodyPr/>
                      <a:lstStyle/>
                      <a:p>
                        <a:pPr algn="ctr" fontAlgn="ctr"/>
                        <a:r>
                          <a:rPr lang="en-US" sz="1400" b="1" i="0" u="none" strike="noStrike" dirty="0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Group S</a:t>
                        </a:r>
                      </a:p>
                    </a:txBody>
                    <a:tcPr marL="8808" marR="8808" marT="8808" marB="0" anchor="ctr"/>
                  </a:tc>
                  <a:tc>
                    <a:txBody>
                      <a:bodyPr/>
                      <a:lstStyle/>
                      <a:p>
                        <a:pPr algn="ctr" fontAlgn="ctr"/>
                        <a:r>
                          <a:rPr lang="en-US" sz="1400" b="1" u="none" strike="noStrike" dirty="0">
                            <a:effectLst/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Annotation</a:t>
                        </a:r>
                        <a:endPara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endParaRPr>
                      </a:p>
                    </a:txBody>
                    <a:tcPr marL="8808" marR="8808" marT="8808" marB="0" anchor="ctr"/>
                  </a:tc>
                  <a:extLst>
                    <a:ext uri="{0D108BD9-81ED-4DB2-BD59-A6C34878D82A}">
                      <a16:rowId xmlns:a16="http://schemas.microsoft.com/office/drawing/2014/main" val="2549059131"/>
                    </a:ext>
                  </a:extLst>
                </a:tr>
                <a:tr h="215538"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 dirty="0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102625194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4.81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2.89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chlorophyll a-b binding protein 13, chloroplastic</a:t>
                        </a:r>
                      </a:p>
                    </a:txBody>
                    <a:tcPr marL="0" marR="0" marT="0" marB="0" anchor="b"/>
                  </a:tc>
                  <a:extLst>
                    <a:ext uri="{0D108BD9-81ED-4DB2-BD59-A6C34878D82A}">
                      <a16:rowId xmlns:a16="http://schemas.microsoft.com/office/drawing/2014/main" val="617098993"/>
                    </a:ext>
                  </a:extLst>
                </a:tr>
                <a:tr h="215538"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102613923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3.34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4.47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chlorophyll a-b binding protein 8, chloroplastic</a:t>
                        </a:r>
                      </a:p>
                    </a:txBody>
                    <a:tcPr marL="0" marR="0" marT="0" marB="0" anchor="b"/>
                  </a:tc>
                  <a:extLst>
                    <a:ext uri="{0D108BD9-81ED-4DB2-BD59-A6C34878D82A}">
                      <a16:rowId xmlns:a16="http://schemas.microsoft.com/office/drawing/2014/main" val="710300477"/>
                    </a:ext>
                  </a:extLst>
                </a:tr>
                <a:tr h="215538"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102625299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5.18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5.66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chlorophyll a-b binding protein of LHCII type 1</a:t>
                        </a:r>
                      </a:p>
                    </a:txBody>
                    <a:tcPr marL="0" marR="0" marT="0" marB="0" anchor="b"/>
                  </a:tc>
                  <a:extLst>
                    <a:ext uri="{0D108BD9-81ED-4DB2-BD59-A6C34878D82A}">
                      <a16:rowId xmlns:a16="http://schemas.microsoft.com/office/drawing/2014/main" val="21582586"/>
                    </a:ext>
                  </a:extLst>
                </a:tr>
                <a:tr h="215538"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102626435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5.10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5.59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chlorophyll a-b binding protein of LHCII type 1</a:t>
                        </a:r>
                      </a:p>
                    </a:txBody>
                    <a:tcPr marL="0" marR="0" marT="0" marB="0" anchor="b"/>
                  </a:tc>
                  <a:extLst>
                    <a:ext uri="{0D108BD9-81ED-4DB2-BD59-A6C34878D82A}">
                      <a16:rowId xmlns:a16="http://schemas.microsoft.com/office/drawing/2014/main" val="3616239565"/>
                    </a:ext>
                  </a:extLst>
                </a:tr>
                <a:tr h="215538"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102625853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5.15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5.82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chlorophyll a-b binding protein of LHCII type 1</a:t>
                        </a:r>
                      </a:p>
                    </a:txBody>
                    <a:tcPr marL="0" marR="0" marT="0" marB="0" anchor="b"/>
                  </a:tc>
                  <a:extLst>
                    <a:ext uri="{0D108BD9-81ED-4DB2-BD59-A6C34878D82A}">
                      <a16:rowId xmlns:a16="http://schemas.microsoft.com/office/drawing/2014/main" val="51883936"/>
                    </a:ext>
                  </a:extLst>
                </a:tr>
                <a:tr h="215538"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102630539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3.66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4.83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chlorophyll a-b binding protein P4, chloroplastic</a:t>
                        </a:r>
                      </a:p>
                    </a:txBody>
                    <a:tcPr marL="0" marR="0" marT="0" marB="0" anchor="b"/>
                  </a:tc>
                  <a:extLst>
                    <a:ext uri="{0D108BD9-81ED-4DB2-BD59-A6C34878D82A}">
                      <a16:rowId xmlns:a16="http://schemas.microsoft.com/office/drawing/2014/main" val="1851316677"/>
                    </a:ext>
                  </a:extLst>
                </a:tr>
                <a:tr h="215538"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102612082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3.83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3.93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cryptochrome DASH, chloroplastic/mitochondrial</a:t>
                        </a:r>
                      </a:p>
                    </a:txBody>
                    <a:tcPr marL="0" marR="0" marT="0" marB="0" anchor="b"/>
                  </a:tc>
                  <a:extLst>
                    <a:ext uri="{0D108BD9-81ED-4DB2-BD59-A6C34878D82A}">
                      <a16:rowId xmlns:a16="http://schemas.microsoft.com/office/drawing/2014/main" val="2899974070"/>
                    </a:ext>
                  </a:extLst>
                </a:tr>
                <a:tr h="215538"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102612184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3.06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3.85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cyclic dof factor 3-like</a:t>
                        </a:r>
                      </a:p>
                    </a:txBody>
                    <a:tcPr marL="0" marR="0" marT="0" marB="0" anchor="b"/>
                  </a:tc>
                  <a:extLst>
                    <a:ext uri="{0D108BD9-81ED-4DB2-BD59-A6C34878D82A}">
                      <a16:rowId xmlns:a16="http://schemas.microsoft.com/office/drawing/2014/main" val="3854138317"/>
                    </a:ext>
                  </a:extLst>
                </a:tr>
                <a:tr h="261792"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102630173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4.07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3.7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sz="1400" b="0" i="0" u="none" strike="noStrike" dirty="0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DNA-binding protein SMUBP-2</a:t>
                        </a:r>
                      </a:p>
                    </a:txBody>
                    <a:tcPr marL="0" marR="0" marT="0" marB="0" anchor="b"/>
                  </a:tc>
                  <a:extLst>
                    <a:ext uri="{0D108BD9-81ED-4DB2-BD59-A6C34878D82A}">
                      <a16:rowId xmlns:a16="http://schemas.microsoft.com/office/drawing/2014/main" val="4158159586"/>
                    </a:ext>
                  </a:extLst>
                </a:tr>
                <a:tr h="215538"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102620937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4.64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4.87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GATA-type transcription activator, N-terminal</a:t>
                        </a:r>
                      </a:p>
                    </a:txBody>
                    <a:tcPr marL="0" marR="0" marT="0" marB="0" anchor="b"/>
                  </a:tc>
                  <a:extLst>
                    <a:ext uri="{0D108BD9-81ED-4DB2-BD59-A6C34878D82A}">
                      <a16:rowId xmlns:a16="http://schemas.microsoft.com/office/drawing/2014/main" val="3311205405"/>
                    </a:ext>
                  </a:extLst>
                </a:tr>
                <a:tr h="215538"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 dirty="0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102616348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4.87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5.06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magnesium-chelatase subunit ChlH, chloroplastic</a:t>
                        </a:r>
                      </a:p>
                    </a:txBody>
                    <a:tcPr marL="0" marR="0" marT="0" marB="0" anchor="b"/>
                  </a:tc>
                  <a:extLst>
                    <a:ext uri="{0D108BD9-81ED-4DB2-BD59-A6C34878D82A}">
                      <a16:rowId xmlns:a16="http://schemas.microsoft.com/office/drawing/2014/main" val="2157896534"/>
                    </a:ext>
                  </a:extLst>
                </a:tr>
                <a:tr h="215538"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102627326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5.59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5.25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protein LHY-like</a:t>
                        </a:r>
                      </a:p>
                    </a:txBody>
                    <a:tcPr marL="0" marR="0" marT="0" marB="0" anchor="b"/>
                  </a:tc>
                  <a:extLst>
                    <a:ext uri="{0D108BD9-81ED-4DB2-BD59-A6C34878D82A}">
                      <a16:rowId xmlns:a16="http://schemas.microsoft.com/office/drawing/2014/main" val="939631282"/>
                    </a:ext>
                  </a:extLst>
                </a:tr>
                <a:tr h="215538"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102616093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4.91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4.43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sz="1400" b="0" i="0" u="none" strike="noStrike" dirty="0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protein LNK2</a:t>
                        </a:r>
                      </a:p>
                    </a:txBody>
                    <a:tcPr marL="0" marR="0" marT="0" marB="0" anchor="b"/>
                  </a:tc>
                  <a:extLst>
                    <a:ext uri="{0D108BD9-81ED-4DB2-BD59-A6C34878D82A}">
                      <a16:rowId xmlns:a16="http://schemas.microsoft.com/office/drawing/2014/main" val="1321933593"/>
                    </a:ext>
                  </a:extLst>
                </a:tr>
                <a:tr h="215538"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102610738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4.79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4.31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sz="1400" b="0" i="0" u="none" strike="noStrike" dirty="0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protein PROTON GRADIENT REGULATION 5, chloroplastic</a:t>
                        </a:r>
                      </a:p>
                    </a:txBody>
                    <a:tcPr marL="0" marR="0" marT="0" marB="0" anchor="b"/>
                  </a:tc>
                  <a:extLst>
                    <a:ext uri="{0D108BD9-81ED-4DB2-BD59-A6C34878D82A}">
                      <a16:rowId xmlns:a16="http://schemas.microsoft.com/office/drawing/2014/main" val="1239094452"/>
                    </a:ext>
                  </a:extLst>
                </a:tr>
                <a:tr h="215538"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102615553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3.42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4.2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protochlorophyllide-dependent translocon component 52, chloroplastic</a:t>
                        </a:r>
                      </a:p>
                    </a:txBody>
                    <a:tcPr marL="0" marR="0" marT="0" marB="0" anchor="b"/>
                  </a:tc>
                  <a:extLst>
                    <a:ext uri="{0D108BD9-81ED-4DB2-BD59-A6C34878D82A}">
                      <a16:rowId xmlns:a16="http://schemas.microsoft.com/office/drawing/2014/main" val="1908727527"/>
                    </a:ext>
                  </a:extLst>
                </a:tr>
                <a:tr h="215538"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102618540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3.80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4.1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senescence-associated protein AAF, chlorolplastic</a:t>
                        </a:r>
                      </a:p>
                    </a:txBody>
                    <a:tcPr marL="0" marR="0" marT="0" marB="0" anchor="b"/>
                  </a:tc>
                  <a:extLst>
                    <a:ext uri="{0D108BD9-81ED-4DB2-BD59-A6C34878D82A}">
                      <a16:rowId xmlns:a16="http://schemas.microsoft.com/office/drawing/2014/main" val="3764249331"/>
                    </a:ext>
                  </a:extLst>
                </a:tr>
                <a:tr h="215538"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102614563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3.28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3.93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transcription factor HY5</a:t>
                        </a:r>
                      </a:p>
                    </a:txBody>
                    <a:tcPr marL="0" marR="0" marT="0" marB="0" anchor="b"/>
                  </a:tc>
                  <a:extLst>
                    <a:ext uri="{0D108BD9-81ED-4DB2-BD59-A6C34878D82A}">
                      <a16:rowId xmlns:a16="http://schemas.microsoft.com/office/drawing/2014/main" val="57309468"/>
                    </a:ext>
                  </a:extLst>
                </a:tr>
                <a:tr h="215538"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102610533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3.92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5.03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transcription factor LUX</a:t>
                        </a:r>
                      </a:p>
                    </a:txBody>
                    <a:tcPr marL="0" marR="0" marT="0" marB="0" anchor="b"/>
                  </a:tc>
                  <a:extLst>
                    <a:ext uri="{0D108BD9-81ED-4DB2-BD59-A6C34878D82A}">
                      <a16:rowId xmlns:a16="http://schemas.microsoft.com/office/drawing/2014/main" val="3172848959"/>
                    </a:ext>
                  </a:extLst>
                </a:tr>
                <a:tr h="215538"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102629795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3.394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2.93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transcription factor LUX</a:t>
                        </a:r>
                      </a:p>
                    </a:txBody>
                    <a:tcPr marL="0" marR="0" marT="0" marB="0" anchor="b"/>
                  </a:tc>
                  <a:extLst>
                    <a:ext uri="{0D108BD9-81ED-4DB2-BD59-A6C34878D82A}">
                      <a16:rowId xmlns:a16="http://schemas.microsoft.com/office/drawing/2014/main" val="2787032637"/>
                    </a:ext>
                  </a:extLst>
                </a:tr>
                <a:tr h="215538"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102609482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4.46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5.19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transcription factor PIF7</a:t>
                        </a:r>
                      </a:p>
                    </a:txBody>
                    <a:tcPr marL="0" marR="0" marT="0" marB="0" anchor="b"/>
                  </a:tc>
                  <a:extLst>
                    <a:ext uri="{0D108BD9-81ED-4DB2-BD59-A6C34878D82A}">
                      <a16:rowId xmlns:a16="http://schemas.microsoft.com/office/drawing/2014/main" val="2941823561"/>
                    </a:ext>
                  </a:extLst>
                </a:tr>
                <a:tr h="215538"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102630875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3.18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3.17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two-component response regulator-like APRR3</a:t>
                        </a:r>
                      </a:p>
                    </a:txBody>
                    <a:tcPr marL="0" marR="0" marT="0" marB="0" anchor="b"/>
                  </a:tc>
                  <a:extLst>
                    <a:ext uri="{0D108BD9-81ED-4DB2-BD59-A6C34878D82A}">
                      <a16:rowId xmlns:a16="http://schemas.microsoft.com/office/drawing/2014/main" val="887945160"/>
                    </a:ext>
                  </a:extLst>
                </a:tr>
                <a:tr h="215538"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102631246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3.01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2.55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two-component response regulator-like APRR5</a:t>
                        </a:r>
                      </a:p>
                    </a:txBody>
                    <a:tcPr marL="0" marR="0" marT="0" marB="0" anchor="b"/>
                  </a:tc>
                  <a:extLst>
                    <a:ext uri="{0D108BD9-81ED-4DB2-BD59-A6C34878D82A}">
                      <a16:rowId xmlns:a16="http://schemas.microsoft.com/office/drawing/2014/main" val="2548235602"/>
                    </a:ext>
                  </a:extLst>
                </a:tr>
                <a:tr h="215538"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102622921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7.41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6.84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two-component response regulator-like APRR9</a:t>
                        </a:r>
                      </a:p>
                    </a:txBody>
                    <a:tcPr marL="0" marR="0" marT="0" marB="0" anchor="b"/>
                  </a:tc>
                  <a:extLst>
                    <a:ext uri="{0D108BD9-81ED-4DB2-BD59-A6C34878D82A}">
                      <a16:rowId xmlns:a16="http://schemas.microsoft.com/office/drawing/2014/main" val="1241285135"/>
                    </a:ext>
                  </a:extLst>
                </a:tr>
                <a:tr h="215538"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102619721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3.83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4.05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sz="1400" b="0" i="0" u="none" strike="noStrike" dirty="0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uncharacterized LOC102619721</a:t>
                        </a:r>
                      </a:p>
                    </a:txBody>
                    <a:tcPr marL="0" marR="0" marT="0" marB="0" anchor="b"/>
                  </a:tc>
                  <a:extLst>
                    <a:ext uri="{0D108BD9-81ED-4DB2-BD59-A6C34878D82A}">
                      <a16:rowId xmlns:a16="http://schemas.microsoft.com/office/drawing/2014/main" val="3003907450"/>
                    </a:ext>
                  </a:extLst>
                </a:tr>
                <a:tr h="215538"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102577984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3.80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-3.5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sz="1400" b="0" i="0" u="none" strike="noStrike" dirty="0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zeaxanthin epoxidase, chloroplastic</a:t>
                        </a:r>
                      </a:p>
                    </a:txBody>
                    <a:tcPr marL="0" marR="0" marT="0" marB="0" anchor="b"/>
                  </a:tc>
                  <a:extLst>
                    <a:ext uri="{0D108BD9-81ED-4DB2-BD59-A6C34878D82A}">
                      <a16:rowId xmlns:a16="http://schemas.microsoft.com/office/drawing/2014/main" val="3468374957"/>
                    </a:ext>
                  </a:extLst>
                </a:tr>
              </a:tbl>
            </a:graphicData>
          </a:graphic>
        </p:graphicFrame>
        <p:cxnSp>
          <p:nvCxnSpPr>
            <p:cNvPr id="3" name="直接连接符 2">
              <a:extLst>
                <a:ext uri="{FF2B5EF4-FFF2-40B4-BE49-F238E27FC236}">
                  <a16:creationId xmlns:a16="http://schemas.microsoft.com/office/drawing/2014/main" id="{725FE7B4-013A-DEA2-3E64-D5294653557D}"/>
                </a:ext>
              </a:extLst>
            </p:cNvPr>
            <p:cNvCxnSpPr/>
            <p:nvPr/>
          </p:nvCxnSpPr>
          <p:spPr>
            <a:xfrm>
              <a:off x="1752058" y="729842"/>
              <a:ext cx="8326268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6" name="文本框 21">
            <a:extLst>
              <a:ext uri="{FF2B5EF4-FFF2-40B4-BE49-F238E27FC236}">
                <a16:creationId xmlns:a16="http://schemas.microsoft.com/office/drawing/2014/main" id="{16C060EC-FD9F-A1B1-187C-377BA51283C0}"/>
              </a:ext>
            </a:extLst>
          </p:cNvPr>
          <p:cNvSpPr txBox="1"/>
          <p:nvPr/>
        </p:nvSpPr>
        <p:spPr>
          <a:xfrm>
            <a:off x="141016" y="95688"/>
            <a:ext cx="46189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Table 3</a:t>
            </a: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C7DC81FF-70CB-7475-DC10-3555F579C19C}"/>
              </a:ext>
            </a:extLst>
          </p:cNvPr>
          <p:cNvSpPr txBox="1"/>
          <p:nvPr/>
        </p:nvSpPr>
        <p:spPr>
          <a:xfrm>
            <a:off x="1827814" y="395046"/>
            <a:ext cx="867156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Nod genes excavated from KEGG network analysis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92958116-2B0E-4C08-57E1-02EEEA173E8F}"/>
              </a:ext>
            </a:extLst>
          </p:cNvPr>
          <p:cNvSpPr txBox="1"/>
          <p:nvPr/>
        </p:nvSpPr>
        <p:spPr>
          <a:xfrm>
            <a:off x="1827814" y="6359695"/>
            <a:ext cx="808729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Group D and Group S: represented the gene expression level in experimental group D and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 </a:t>
            </a:r>
            <a:r>
              <a:rPr lang="en-US" altLang="zh-CN" sz="12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at 12hpi, respectively.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567191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>
            <a:extLst>
              <a:ext uri="{FF2B5EF4-FFF2-40B4-BE49-F238E27FC236}">
                <a16:creationId xmlns:a16="http://schemas.microsoft.com/office/drawing/2014/main" id="{B774C8C5-82F8-19A1-DBCE-11C9A680C29F}"/>
              </a:ext>
            </a:extLst>
          </p:cNvPr>
          <p:cNvGrpSpPr>
            <a:grpSpLocks/>
          </p:cNvGrpSpPr>
          <p:nvPr/>
        </p:nvGrpSpPr>
        <p:grpSpPr>
          <a:xfrm>
            <a:off x="1736212" y="1867984"/>
            <a:ext cx="8326268" cy="3122032"/>
            <a:chOff x="1634612" y="803275"/>
            <a:chExt cx="8326268" cy="3122032"/>
          </a:xfrm>
        </p:grpSpPr>
        <p:graphicFrame>
          <p:nvGraphicFramePr>
            <p:cNvPr id="4" name="表格 3">
              <a:extLst>
                <a:ext uri="{FF2B5EF4-FFF2-40B4-BE49-F238E27FC236}">
                  <a16:creationId xmlns:a16="http://schemas.microsoft.com/office/drawing/2014/main" id="{A1FEE015-4AC0-BA0F-976F-2683409E4B4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44590619"/>
                </p:ext>
              </p:extLst>
            </p:nvPr>
          </p:nvGraphicFramePr>
          <p:xfrm>
            <a:off x="1670050" y="803275"/>
            <a:ext cx="8290830" cy="3122032"/>
          </p:xfrm>
          <a:graphic>
            <a:graphicData uri="http://schemas.openxmlformats.org/drawingml/2006/table">
              <a:tbl>
                <a:tblPr>
                  <a:tableStyleId>{9D7B26C5-4107-4FEC-AEDC-1716B250A1EF}</a:tableStyleId>
                </a:tblPr>
                <a:tblGrid>
                  <a:gridCol w="1150016">
                    <a:extLst>
                      <a:ext uri="{9D8B030D-6E8A-4147-A177-3AD203B41FA5}">
                        <a16:colId xmlns:a16="http://schemas.microsoft.com/office/drawing/2014/main" val="1379059727"/>
                      </a:ext>
                    </a:extLst>
                  </a:gridCol>
                  <a:gridCol w="1413789">
                    <a:extLst>
                      <a:ext uri="{9D8B030D-6E8A-4147-A177-3AD203B41FA5}">
                        <a16:colId xmlns:a16="http://schemas.microsoft.com/office/drawing/2014/main" val="1702008205"/>
                      </a:ext>
                    </a:extLst>
                  </a:gridCol>
                  <a:gridCol w="1076010">
                    <a:extLst>
                      <a:ext uri="{9D8B030D-6E8A-4147-A177-3AD203B41FA5}">
                        <a16:colId xmlns:a16="http://schemas.microsoft.com/office/drawing/2014/main" val="4205038024"/>
                      </a:ext>
                    </a:extLst>
                  </a:gridCol>
                  <a:gridCol w="4651015">
                    <a:extLst>
                      <a:ext uri="{9D8B030D-6E8A-4147-A177-3AD203B41FA5}">
                        <a16:colId xmlns:a16="http://schemas.microsoft.com/office/drawing/2014/main" val="1822961654"/>
                      </a:ext>
                    </a:extLst>
                  </a:gridCol>
                </a:tblGrid>
                <a:tr h="222167">
                  <a:tc>
                    <a:txBody>
                      <a:bodyPr/>
                      <a:lstStyle/>
                      <a:p>
                        <a:pPr algn="ctr" fontAlgn="ctr"/>
                        <a:r>
                          <a:rPr lang="en-US" sz="1400" b="1" u="none" strike="noStrike" dirty="0">
                            <a:effectLst/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ID</a:t>
                        </a:r>
                        <a:endPara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endParaRPr>
                      </a:p>
                    </a:txBody>
                    <a:tcPr marL="8808" marR="8808" marT="8808" marB="0" anchor="ctr"/>
                  </a:tc>
                  <a:tc>
                    <a:txBody>
                      <a:bodyPr/>
                      <a:lstStyle/>
                      <a:p>
                        <a:pPr algn="ctr" fontAlgn="ctr"/>
                        <a:r>
                          <a:rPr lang="en-US" sz="1400" b="1" i="0" u="none" strike="noStrike" dirty="0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Group D</a:t>
                        </a:r>
                      </a:p>
                    </a:txBody>
                    <a:tcPr marL="8808" marR="8808" marT="8808" marB="0" anchor="ctr"/>
                  </a:tc>
                  <a:tc>
                    <a:txBody>
                      <a:bodyPr/>
                      <a:lstStyle/>
                      <a:p>
                        <a:pPr algn="ctr" fontAlgn="ctr"/>
                        <a:r>
                          <a:rPr lang="en-US" sz="1400" b="1" i="0" u="none" strike="noStrike" dirty="0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等线" panose="02010600030101010101" pitchFamily="2" charset="-122"/>
                            <a:cs typeface="Arial" panose="020B0604020202020204" pitchFamily="34" charset="0"/>
                          </a:rPr>
                          <a:t>Group S</a:t>
                        </a:r>
                      </a:p>
                    </a:txBody>
                    <a:tcPr marL="8808" marR="8808" marT="8808" marB="0" anchor="ctr"/>
                  </a:tc>
                  <a:tc>
                    <a:txBody>
                      <a:bodyPr/>
                      <a:lstStyle/>
                      <a:p>
                        <a:pPr algn="ctr" fontAlgn="ctr"/>
                        <a:r>
                          <a:rPr lang="en-US" sz="1400" b="1" u="none" strike="noStrike" dirty="0">
                            <a:effectLst/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Annotation</a:t>
                        </a:r>
                        <a:endPara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endParaRPr>
                      </a:p>
                    </a:txBody>
                    <a:tcPr marL="8808" marR="8808" marT="8808" marB="0" anchor="ctr"/>
                  </a:tc>
                  <a:extLst>
                    <a:ext uri="{0D108BD9-81ED-4DB2-BD59-A6C34878D82A}">
                      <a16:rowId xmlns:a16="http://schemas.microsoft.com/office/drawing/2014/main" val="2549059131"/>
                    </a:ext>
                  </a:extLst>
                </a:tr>
                <a:tr h="222167"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102622921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-7.42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-6.84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ctr"/>
                        <a:r>
                          <a:rPr lang="en-US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two-component response regulator-like APRR9</a:t>
                        </a:r>
                      </a:p>
                    </a:txBody>
                    <a:tcPr marL="8808" marR="8808" marT="8808" marB="0" anchor="ctr"/>
                  </a:tc>
                  <a:extLst>
                    <a:ext uri="{0D108BD9-81ED-4DB2-BD59-A6C34878D82A}">
                      <a16:rowId xmlns:a16="http://schemas.microsoft.com/office/drawing/2014/main" val="3616239565"/>
                    </a:ext>
                  </a:extLst>
                </a:tr>
                <a:tr h="222167"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102616615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-7.78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-5.41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ctr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B-box zinc finger protein 32-like</a:t>
                        </a:r>
                        <a:endParaRPr lang="en-US" sz="14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endParaRPr>
                      </a:p>
                    </a:txBody>
                    <a:tcPr marL="8808" marR="8808" marT="8808" marB="0" anchor="ctr"/>
                  </a:tc>
                  <a:extLst>
                    <a:ext uri="{0D108BD9-81ED-4DB2-BD59-A6C34878D82A}">
                      <a16:rowId xmlns:a16="http://schemas.microsoft.com/office/drawing/2014/main" val="51883936"/>
                    </a:ext>
                  </a:extLst>
                </a:tr>
                <a:tr h="222167"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102625299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-5.18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-5.66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ctr"/>
                        <a:r>
                          <a:rPr lang="en-US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chlorophyll a-b binding protein of LHCII type 1</a:t>
                        </a:r>
                      </a:p>
                    </a:txBody>
                    <a:tcPr marL="8808" marR="8808" marT="8808" marB="0" anchor="ctr"/>
                  </a:tc>
                  <a:extLst>
                    <a:ext uri="{0D108BD9-81ED-4DB2-BD59-A6C34878D82A}">
                      <a16:rowId xmlns:a16="http://schemas.microsoft.com/office/drawing/2014/main" val="2899974070"/>
                    </a:ext>
                  </a:extLst>
                </a:tr>
                <a:tr h="222167"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102625194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-4.82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-4.96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ctr"/>
                        <a:r>
                          <a:rPr lang="en-US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chlorophyll a-b binding protein 13, chloroplastic</a:t>
                        </a:r>
                      </a:p>
                    </a:txBody>
                    <a:tcPr marL="8808" marR="8808" marT="8808" marB="0" anchor="ctr"/>
                  </a:tc>
                  <a:extLst>
                    <a:ext uri="{0D108BD9-81ED-4DB2-BD59-A6C34878D82A}">
                      <a16:rowId xmlns:a16="http://schemas.microsoft.com/office/drawing/2014/main" val="3311205405"/>
                    </a:ext>
                  </a:extLst>
                </a:tr>
                <a:tr h="222167"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102624748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-7.7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-2.92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ctr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ABC transporter G family member 11-like</a:t>
                        </a:r>
                        <a:endParaRPr lang="en-US" sz="14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endParaRPr>
                      </a:p>
                    </a:txBody>
                    <a:tcPr marL="8808" marR="8808" marT="8808" marB="0" anchor="ctr"/>
                  </a:tc>
                  <a:extLst>
                    <a:ext uri="{0D108BD9-81ED-4DB2-BD59-A6C34878D82A}">
                      <a16:rowId xmlns:a16="http://schemas.microsoft.com/office/drawing/2014/main" val="1321933593"/>
                    </a:ext>
                  </a:extLst>
                </a:tr>
                <a:tr h="222167"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102626435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-5.11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-5.59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ctr"/>
                        <a:r>
                          <a:rPr lang="en-US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chlorophyll a-b binding protein of LHCII type 1</a:t>
                        </a:r>
                      </a:p>
                    </a:txBody>
                    <a:tcPr marL="8808" marR="8808" marT="8808" marB="0" anchor="ctr"/>
                  </a:tc>
                  <a:extLst>
                    <a:ext uri="{0D108BD9-81ED-4DB2-BD59-A6C34878D82A}">
                      <a16:rowId xmlns:a16="http://schemas.microsoft.com/office/drawing/2014/main" val="1239094452"/>
                    </a:ext>
                  </a:extLst>
                </a:tr>
                <a:tr h="222167"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102630539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-3.67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-4.83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ctr"/>
                        <a:r>
                          <a:rPr lang="en-US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chlorophyll a-b binding protein P4, chloroplastic</a:t>
                        </a:r>
                      </a:p>
                    </a:txBody>
                    <a:tcPr marL="8808" marR="8808" marT="8808" marB="0" anchor="ctr"/>
                  </a:tc>
                  <a:extLst>
                    <a:ext uri="{0D108BD9-81ED-4DB2-BD59-A6C34878D82A}">
                      <a16:rowId xmlns:a16="http://schemas.microsoft.com/office/drawing/2014/main" val="1908727527"/>
                    </a:ext>
                  </a:extLst>
                </a:tr>
                <a:tr h="222167"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102627326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-5.59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-5.25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ctr"/>
                        <a:r>
                          <a:rPr lang="en-US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protein LHY-like</a:t>
                        </a:r>
                      </a:p>
                    </a:txBody>
                    <a:tcPr marL="8808" marR="8808" marT="8808" marB="0" anchor="ctr"/>
                  </a:tc>
                  <a:extLst>
                    <a:ext uri="{0D108BD9-81ED-4DB2-BD59-A6C34878D82A}">
                      <a16:rowId xmlns:a16="http://schemas.microsoft.com/office/drawing/2014/main" val="3764249331"/>
                    </a:ext>
                  </a:extLst>
                </a:tr>
                <a:tr h="222167"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102613923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-3.35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-4.47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ctr"/>
                        <a:r>
                          <a:rPr lang="en-US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chlorophyll a-b binding protein 8, chloroplastic</a:t>
                        </a:r>
                      </a:p>
                    </a:txBody>
                    <a:tcPr marL="8808" marR="8808" marT="8808" marB="0" anchor="ctr"/>
                  </a:tc>
                  <a:extLst>
                    <a:ext uri="{0D108BD9-81ED-4DB2-BD59-A6C34878D82A}">
                      <a16:rowId xmlns:a16="http://schemas.microsoft.com/office/drawing/2014/main" val="57309468"/>
                    </a:ext>
                  </a:extLst>
                </a:tr>
                <a:tr h="222167"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102623467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4.34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3.17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ctr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 amino acid transporter AVT1C</a:t>
                        </a:r>
                        <a:endParaRPr lang="en-US" sz="14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endParaRPr>
                      </a:p>
                    </a:txBody>
                    <a:tcPr marL="8808" marR="8808" marT="8808" marB="0" anchor="ctr"/>
                  </a:tc>
                  <a:extLst>
                    <a:ext uri="{0D108BD9-81ED-4DB2-BD59-A6C34878D82A}">
                      <a16:rowId xmlns:a16="http://schemas.microsoft.com/office/drawing/2014/main" val="3172848959"/>
                    </a:ext>
                  </a:extLst>
                </a:tr>
                <a:tr h="222167"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102621116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5.16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4.86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ctr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bifunctional UDP-glucose 4-epimerase</a:t>
                        </a:r>
                        <a:endParaRPr lang="en-US" sz="14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endParaRPr>
                      </a:p>
                    </a:txBody>
                    <a:tcPr marL="8808" marR="8808" marT="8808" marB="0" anchor="ctr"/>
                  </a:tc>
                  <a:extLst>
                    <a:ext uri="{0D108BD9-81ED-4DB2-BD59-A6C34878D82A}">
                      <a16:rowId xmlns:a16="http://schemas.microsoft.com/office/drawing/2014/main" val="2787032637"/>
                    </a:ext>
                  </a:extLst>
                </a:tr>
                <a:tr h="222167"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102610999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4.87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6.11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ctr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peroxidase 10</a:t>
                        </a:r>
                        <a:endParaRPr lang="en-US" sz="14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endParaRPr>
                      </a:p>
                    </a:txBody>
                    <a:tcPr marL="8808" marR="8808" marT="8808" marB="0" anchor="ctr"/>
                  </a:tc>
                  <a:extLst>
                    <a:ext uri="{0D108BD9-81ED-4DB2-BD59-A6C34878D82A}">
                      <a16:rowId xmlns:a16="http://schemas.microsoft.com/office/drawing/2014/main" val="2941823561"/>
                    </a:ext>
                  </a:extLst>
                </a:tr>
                <a:tr h="233848"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102612910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4.84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b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5.63</a:t>
                        </a:r>
                      </a:p>
                    </a:txBody>
                    <a:tcPr marL="0" marR="0" marT="0" marB="0" anchor="b"/>
                  </a:tc>
                  <a:tc>
                    <a:txBody>
                      <a:bodyPr/>
                      <a:lstStyle/>
                      <a:p>
                        <a:pPr algn="ctr" fontAlgn="ctr"/>
                        <a:r>
                          <a:rPr lang="en-US" altLang="zh-CN" sz="1400" u="none" strike="noStrike" kern="1200" dirty="0">
                            <a:solidFill>
                              <a:schemeClr val="tx1"/>
                            </a:solidFill>
                            <a:effectLst/>
                            <a:latin typeface="Arial" panose="020B0604020202020204" pitchFamily="34" charset="0"/>
                            <a:ea typeface="+mn-ea"/>
                            <a:cs typeface="Arial" panose="020B0604020202020204" pitchFamily="34" charset="0"/>
                          </a:rPr>
                          <a:t>salicylic acid-binding protein 2-like</a:t>
                        </a:r>
                        <a:endParaRPr lang="en-US" sz="14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endParaRPr>
                      </a:p>
                    </a:txBody>
                    <a:tcPr marL="8808" marR="8808" marT="8808" marB="0" anchor="ctr"/>
                  </a:tc>
                  <a:extLst>
                    <a:ext uri="{0D108BD9-81ED-4DB2-BD59-A6C34878D82A}">
                      <a16:rowId xmlns:a16="http://schemas.microsoft.com/office/drawing/2014/main" val="887945160"/>
                    </a:ext>
                  </a:extLst>
                </a:tr>
              </a:tbl>
            </a:graphicData>
          </a:graphic>
        </p:graphicFrame>
        <p:cxnSp>
          <p:nvCxnSpPr>
            <p:cNvPr id="6" name="直接连接符 5">
              <a:extLst>
                <a:ext uri="{FF2B5EF4-FFF2-40B4-BE49-F238E27FC236}">
                  <a16:creationId xmlns:a16="http://schemas.microsoft.com/office/drawing/2014/main" id="{30636B58-8BA7-3A5A-FD01-382FDFCF0226}"/>
                </a:ext>
              </a:extLst>
            </p:cNvPr>
            <p:cNvCxnSpPr>
              <a:cxnSpLocks/>
            </p:cNvCxnSpPr>
            <p:nvPr/>
          </p:nvCxnSpPr>
          <p:spPr>
            <a:xfrm>
              <a:off x="1634612" y="1061613"/>
              <a:ext cx="8326268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" name="文本框 1">
            <a:extLst>
              <a:ext uri="{FF2B5EF4-FFF2-40B4-BE49-F238E27FC236}">
                <a16:creationId xmlns:a16="http://schemas.microsoft.com/office/drawing/2014/main" id="{03BC1A94-930E-9FCA-7C9E-834468BAA6CB}"/>
              </a:ext>
            </a:extLst>
          </p:cNvPr>
          <p:cNvSpPr txBox="1">
            <a:spLocks noGrp="1" noRot="1" noMove="1" noResize="1" noEditPoints="1" noAdjustHandles="1" noChangeArrowheads="1" noChangeShapeType="1"/>
          </p:cNvSpPr>
          <p:nvPr/>
        </p:nvSpPr>
        <p:spPr>
          <a:xfrm>
            <a:off x="1736212" y="1460399"/>
            <a:ext cx="5597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Significantly enriched DEGs selected for the verification of qRT-PCR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FFAB997E-568D-63C0-64C8-D660527C4E97}"/>
              </a:ext>
            </a:extLst>
          </p:cNvPr>
          <p:cNvSpPr txBox="1"/>
          <p:nvPr/>
        </p:nvSpPr>
        <p:spPr>
          <a:xfrm>
            <a:off x="1736212" y="5025042"/>
            <a:ext cx="808729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Group D and Group S: represented the gene expression level in experimental group D and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 </a:t>
            </a:r>
            <a:r>
              <a:rPr lang="en-US" altLang="zh-CN" sz="12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at 12hpi, respectively.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21">
            <a:extLst>
              <a:ext uri="{FF2B5EF4-FFF2-40B4-BE49-F238E27FC236}">
                <a16:creationId xmlns:a16="http://schemas.microsoft.com/office/drawing/2014/main" id="{F1EACFE4-DAEE-77F0-BBC1-4AC96FDB51E8}"/>
              </a:ext>
            </a:extLst>
          </p:cNvPr>
          <p:cNvSpPr txBox="1"/>
          <p:nvPr/>
        </p:nvSpPr>
        <p:spPr>
          <a:xfrm>
            <a:off x="141016" y="95688"/>
            <a:ext cx="46189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Table 4</a:t>
            </a:r>
          </a:p>
        </p:txBody>
      </p:sp>
    </p:spTree>
    <p:extLst>
      <p:ext uri="{BB962C8B-B14F-4D97-AF65-F5344CB8AC3E}">
        <p14:creationId xmlns:p14="http://schemas.microsoft.com/office/powerpoint/2010/main" val="122055408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4CE34C29-B0F5-C854-DA8F-59EF6007972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21601862"/>
              </p:ext>
            </p:extLst>
          </p:nvPr>
        </p:nvGraphicFramePr>
        <p:xfrm>
          <a:off x="2800349" y="118804"/>
          <a:ext cx="5838825" cy="6620392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075883">
                  <a:extLst>
                    <a:ext uri="{9D8B030D-6E8A-4147-A177-3AD203B41FA5}">
                      <a16:colId xmlns:a16="http://schemas.microsoft.com/office/drawing/2014/main" val="1325425578"/>
                    </a:ext>
                  </a:extLst>
                </a:gridCol>
                <a:gridCol w="1221651">
                  <a:extLst>
                    <a:ext uri="{9D8B030D-6E8A-4147-A177-3AD203B41FA5}">
                      <a16:colId xmlns:a16="http://schemas.microsoft.com/office/drawing/2014/main" val="163040644"/>
                    </a:ext>
                  </a:extLst>
                </a:gridCol>
                <a:gridCol w="3541291">
                  <a:extLst>
                    <a:ext uri="{9D8B030D-6E8A-4147-A177-3AD203B41FA5}">
                      <a16:colId xmlns:a16="http://schemas.microsoft.com/office/drawing/2014/main" val="3873428478"/>
                    </a:ext>
                  </a:extLst>
                </a:gridCol>
              </a:tblGrid>
              <a:tr h="254144"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ID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 name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 (5’ to 3’ orientation)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extLst>
                  <a:ext uri="{0D108BD9-81ED-4DB2-BD59-A6C34878D82A}">
                    <a16:rowId xmlns:a16="http://schemas.microsoft.com/office/drawing/2014/main" val="3429817961"/>
                  </a:ext>
                </a:extLst>
              </a:tr>
              <a:tr h="133390"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altLang="zh-CN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2622921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-2292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AACCAAAGATGCTAACGCC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extLst>
                  <a:ext uri="{0D108BD9-81ED-4DB2-BD59-A6C34878D82A}">
                    <a16:rowId xmlns:a16="http://schemas.microsoft.com/office/drawing/2014/main" val="925636710"/>
                  </a:ext>
                </a:extLst>
              </a:tr>
              <a:tr h="133390"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altLang="zh-CN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2622921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-2292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CAACTCCAAAAGAACCTGC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extLst>
                  <a:ext uri="{0D108BD9-81ED-4DB2-BD59-A6C34878D82A}">
                    <a16:rowId xmlns:a16="http://schemas.microsoft.com/office/drawing/2014/main" val="732695041"/>
                  </a:ext>
                </a:extLst>
              </a:tr>
              <a:tr h="133390"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altLang="zh-CN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2616615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-1661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AACCACAAAATAGAAACCAC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extLst>
                  <a:ext uri="{0D108BD9-81ED-4DB2-BD59-A6C34878D82A}">
                    <a16:rowId xmlns:a16="http://schemas.microsoft.com/office/drawing/2014/main" val="3670564200"/>
                  </a:ext>
                </a:extLst>
              </a:tr>
              <a:tr h="133390"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altLang="zh-CN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2616615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-1661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GATCAAAGGTAGGCCGTAA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extLst>
                  <a:ext uri="{0D108BD9-81ED-4DB2-BD59-A6C34878D82A}">
                    <a16:rowId xmlns:a16="http://schemas.microsoft.com/office/drawing/2014/main" val="3118310905"/>
                  </a:ext>
                </a:extLst>
              </a:tr>
              <a:tr h="133390"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altLang="zh-CN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2625299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-25299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AACCTTCCATTCTTGATTTCC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extLst>
                  <a:ext uri="{0D108BD9-81ED-4DB2-BD59-A6C34878D82A}">
                    <a16:rowId xmlns:a16="http://schemas.microsoft.com/office/drawing/2014/main" val="1359356014"/>
                  </a:ext>
                </a:extLst>
              </a:tr>
              <a:tr h="133390"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altLang="zh-CN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2630539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-30539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AACCCAGGAAGTGTCAAC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extLst>
                  <a:ext uri="{0D108BD9-81ED-4DB2-BD59-A6C34878D82A}">
                    <a16:rowId xmlns:a16="http://schemas.microsoft.com/office/drawing/2014/main" val="236906529"/>
                  </a:ext>
                </a:extLst>
              </a:tr>
              <a:tr h="133390"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altLang="zh-CN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2625194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-25194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AACCCCAACCTTGTTCAT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extLst>
                  <a:ext uri="{0D108BD9-81ED-4DB2-BD59-A6C34878D82A}">
                    <a16:rowId xmlns:a16="http://schemas.microsoft.com/office/drawing/2014/main" val="2894113842"/>
                  </a:ext>
                </a:extLst>
              </a:tr>
              <a:tr h="133390"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altLang="zh-CN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2625194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-25194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ATACGGAAACCCTCAAC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extLst>
                  <a:ext uri="{0D108BD9-81ED-4DB2-BD59-A6C34878D82A}">
                    <a16:rowId xmlns:a16="http://schemas.microsoft.com/office/drawing/2014/main" val="1731968857"/>
                  </a:ext>
                </a:extLst>
              </a:tr>
              <a:tr h="133390"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altLang="zh-CN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2624748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-24748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ATGGGTCCTTCTGGTTGT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extLst>
                  <a:ext uri="{0D108BD9-81ED-4DB2-BD59-A6C34878D82A}">
                    <a16:rowId xmlns:a16="http://schemas.microsoft.com/office/drawing/2014/main" val="4137188849"/>
                  </a:ext>
                </a:extLst>
              </a:tr>
              <a:tr h="133390"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altLang="zh-CN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2624748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-24748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TCACATATGCCGAGGTTC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extLst>
                  <a:ext uri="{0D108BD9-81ED-4DB2-BD59-A6C34878D82A}">
                    <a16:rowId xmlns:a16="http://schemas.microsoft.com/office/drawing/2014/main" val="121959894"/>
                  </a:ext>
                </a:extLst>
              </a:tr>
              <a:tr h="133390"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altLang="zh-CN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2626435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-2643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AAGGGACCGTTAGAGAAC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extLst>
                  <a:ext uri="{0D108BD9-81ED-4DB2-BD59-A6C34878D82A}">
                    <a16:rowId xmlns:a16="http://schemas.microsoft.com/office/drawing/2014/main" val="3956973004"/>
                  </a:ext>
                </a:extLst>
              </a:tr>
              <a:tr h="148635"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altLang="zh-CN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2626435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-2643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TCACAACAGATTTACATGATATCC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extLst>
                  <a:ext uri="{0D108BD9-81ED-4DB2-BD59-A6C34878D82A}">
                    <a16:rowId xmlns:a16="http://schemas.microsoft.com/office/drawing/2014/main" val="3991809902"/>
                  </a:ext>
                </a:extLst>
              </a:tr>
              <a:tr h="133390"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altLang="zh-CN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2630539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-30539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AACCCAGGAAGTGTCAAC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extLst>
                  <a:ext uri="{0D108BD9-81ED-4DB2-BD59-A6C34878D82A}">
                    <a16:rowId xmlns:a16="http://schemas.microsoft.com/office/drawing/2014/main" val="743335647"/>
                  </a:ext>
                </a:extLst>
              </a:tr>
              <a:tr h="133390"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altLang="zh-CN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2630539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-30539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TCTCCTTTGCCTCGTCA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extLst>
                  <a:ext uri="{0D108BD9-81ED-4DB2-BD59-A6C34878D82A}">
                    <a16:rowId xmlns:a16="http://schemas.microsoft.com/office/drawing/2014/main" val="2124525625"/>
                  </a:ext>
                </a:extLst>
              </a:tr>
              <a:tr h="133390"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altLang="zh-CN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2627326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-27326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ATTGCTCCTTGGTTTCCC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extLst>
                  <a:ext uri="{0D108BD9-81ED-4DB2-BD59-A6C34878D82A}">
                    <a16:rowId xmlns:a16="http://schemas.microsoft.com/office/drawing/2014/main" val="3585516604"/>
                  </a:ext>
                </a:extLst>
              </a:tr>
              <a:tr h="133390"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altLang="zh-CN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2627326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-27326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AGAATTCACCTGCGACTT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extLst>
                  <a:ext uri="{0D108BD9-81ED-4DB2-BD59-A6C34878D82A}">
                    <a16:rowId xmlns:a16="http://schemas.microsoft.com/office/drawing/2014/main" val="3763096655"/>
                  </a:ext>
                </a:extLst>
              </a:tr>
              <a:tr h="133390"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altLang="zh-CN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2613923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-1392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GGCCTTTGCTTATTCTCC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extLst>
                  <a:ext uri="{0D108BD9-81ED-4DB2-BD59-A6C34878D82A}">
                    <a16:rowId xmlns:a16="http://schemas.microsoft.com/office/drawing/2014/main" val="98826479"/>
                  </a:ext>
                </a:extLst>
              </a:tr>
              <a:tr h="133390"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altLang="zh-CN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2613923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-1392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TTGTCTCGCAGTCTCCAC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extLst>
                  <a:ext uri="{0D108BD9-81ED-4DB2-BD59-A6C34878D82A}">
                    <a16:rowId xmlns:a16="http://schemas.microsoft.com/office/drawing/2014/main" val="2476482202"/>
                  </a:ext>
                </a:extLst>
              </a:tr>
              <a:tr h="133390"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altLang="zh-CN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2623467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-2346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GTTTGATGTAAATGGAGGC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extLst>
                  <a:ext uri="{0D108BD9-81ED-4DB2-BD59-A6C34878D82A}">
                    <a16:rowId xmlns:a16="http://schemas.microsoft.com/office/drawing/2014/main" val="2926675022"/>
                  </a:ext>
                </a:extLst>
              </a:tr>
              <a:tr h="133390"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altLang="zh-CN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2623467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-2346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CTTGGAGATGGGACACTAC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extLst>
                  <a:ext uri="{0D108BD9-81ED-4DB2-BD59-A6C34878D82A}">
                    <a16:rowId xmlns:a16="http://schemas.microsoft.com/office/drawing/2014/main" val="2509598431"/>
                  </a:ext>
                </a:extLst>
              </a:tr>
              <a:tr h="133390"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altLang="zh-CN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2621116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-21116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GGGTGATCTTAGGAACAAG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extLst>
                  <a:ext uri="{0D108BD9-81ED-4DB2-BD59-A6C34878D82A}">
                    <a16:rowId xmlns:a16="http://schemas.microsoft.com/office/drawing/2014/main" val="2504654612"/>
                  </a:ext>
                </a:extLst>
              </a:tr>
              <a:tr h="133390"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altLang="zh-CN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2621116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-21116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GCCTGATACAGATTGATG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extLst>
                  <a:ext uri="{0D108BD9-81ED-4DB2-BD59-A6C34878D82A}">
                    <a16:rowId xmlns:a16="http://schemas.microsoft.com/office/drawing/2014/main" val="3749898359"/>
                  </a:ext>
                </a:extLst>
              </a:tr>
              <a:tr h="104375"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altLang="zh-CN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2610999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-10999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ATGGTGAAGATGAGTAATATTGG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extLst>
                  <a:ext uri="{0D108BD9-81ED-4DB2-BD59-A6C34878D82A}">
                    <a16:rowId xmlns:a16="http://schemas.microsoft.com/office/drawing/2014/main" val="1164977088"/>
                  </a:ext>
                </a:extLst>
              </a:tr>
              <a:tr h="108784"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altLang="zh-CN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2610999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-10999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ATACAGACATTTTGATTCTCGCA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extLst>
                  <a:ext uri="{0D108BD9-81ED-4DB2-BD59-A6C34878D82A}">
                    <a16:rowId xmlns:a16="http://schemas.microsoft.com/office/drawing/2014/main" val="81014352"/>
                  </a:ext>
                </a:extLst>
              </a:tr>
              <a:tr h="133390"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altLang="zh-CN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2612910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-1291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TGGCTGTTTTCGTAACT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extLst>
                  <a:ext uri="{0D108BD9-81ED-4DB2-BD59-A6C34878D82A}">
                    <a16:rowId xmlns:a16="http://schemas.microsoft.com/office/drawing/2014/main" val="4267570195"/>
                  </a:ext>
                </a:extLst>
              </a:tr>
              <a:tr h="133390"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altLang="zh-CN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2612910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-1291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GTCCTCTTTTCCCATCTTC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extLst>
                  <a:ext uri="{0D108BD9-81ED-4DB2-BD59-A6C34878D82A}">
                    <a16:rowId xmlns:a16="http://schemas.microsoft.com/office/drawing/2014/main" val="321514516"/>
                  </a:ext>
                </a:extLst>
              </a:tr>
              <a:tr h="133390"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altLang="zh-CN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2614495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-1449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TGTTTCGGTCGACTTCA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extLst>
                  <a:ext uri="{0D108BD9-81ED-4DB2-BD59-A6C34878D82A}">
                    <a16:rowId xmlns:a16="http://schemas.microsoft.com/office/drawing/2014/main" val="3711584956"/>
                  </a:ext>
                </a:extLst>
              </a:tr>
              <a:tr h="133390"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altLang="zh-CN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2614495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-1449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ts val="2100"/>
                        </a:lnSpc>
                      </a:pPr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TGTCGTACCATGCAATCA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021" marR="7021" marT="7021" marB="0" anchor="b"/>
                </a:tc>
                <a:extLst>
                  <a:ext uri="{0D108BD9-81ED-4DB2-BD59-A6C34878D82A}">
                    <a16:rowId xmlns:a16="http://schemas.microsoft.com/office/drawing/2014/main" val="2917831482"/>
                  </a:ext>
                </a:extLst>
              </a:tr>
            </a:tbl>
          </a:graphicData>
        </a:graphic>
      </p:graphicFrame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10CCC103-76F7-F313-3DB6-9E51668760C9}"/>
              </a:ext>
            </a:extLst>
          </p:cNvPr>
          <p:cNvCxnSpPr/>
          <p:nvPr/>
        </p:nvCxnSpPr>
        <p:spPr>
          <a:xfrm>
            <a:off x="2800348" y="381000"/>
            <a:ext cx="583882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文本框 21">
            <a:extLst>
              <a:ext uri="{FF2B5EF4-FFF2-40B4-BE49-F238E27FC236}">
                <a16:creationId xmlns:a16="http://schemas.microsoft.com/office/drawing/2014/main" id="{709E5809-5E39-DA55-2CEA-FA5A361B7BD7}"/>
              </a:ext>
            </a:extLst>
          </p:cNvPr>
          <p:cNvSpPr txBox="1"/>
          <p:nvPr/>
        </p:nvSpPr>
        <p:spPr>
          <a:xfrm>
            <a:off x="141016" y="95688"/>
            <a:ext cx="46189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Table 5</a:t>
            </a:r>
          </a:p>
        </p:txBody>
      </p:sp>
    </p:spTree>
    <p:extLst>
      <p:ext uri="{BB962C8B-B14F-4D97-AF65-F5344CB8AC3E}">
        <p14:creationId xmlns:p14="http://schemas.microsoft.com/office/powerpoint/2010/main" val="21283828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44</TotalTime>
  <Words>938</Words>
  <Application>Microsoft Office PowerPoint</Application>
  <PresentationFormat>宽屏</PresentationFormat>
  <Paragraphs>477</Paragraphs>
  <Slides>6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1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 Min</dc:creator>
  <cp:lastModifiedBy>鲍 敏丽</cp:lastModifiedBy>
  <cp:revision>12</cp:revision>
  <dcterms:created xsi:type="dcterms:W3CDTF">2022-05-09T08:08:19Z</dcterms:created>
  <dcterms:modified xsi:type="dcterms:W3CDTF">2022-07-29T09:05:30Z</dcterms:modified>
</cp:coreProperties>
</file>